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wmf" ContentType="image/x-wmf"/>
  <Override PartName="/ppt/media/image6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E3FC63-60ED-47E3-9CFB-05C454CFB58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626723-6B91-46DB-BA19-84522EC3AAA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D28736-26B1-4B60-8C82-33E8CA42A63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9544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6232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2856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9544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6232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01CF00-C6CA-4EB3-BA43-B52F9D7CD3D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0FB444-DABF-4597-8D2B-8B8506640DA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B597BE-B61E-4676-A3E6-F9F3346CFD0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0B74D0-9478-4EA8-9ED9-C4DE4CFA069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DE720B-5142-49AD-AE77-47C54BF6DA7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28560" y="365040"/>
            <a:ext cx="7886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1E69B1-9F68-4C7D-B112-0000B37CF5F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DAE258-4872-406A-8CEB-17A96F53232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03C006-1895-4F92-BD5B-0D043806FBB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95F3F8-A202-45DD-B0E8-0087E12B08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ptos Display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ptos Display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ptos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ptos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ptos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ptos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ptos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ptos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ptos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2820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200" spc="-1" strike="noStrike">
                <a:solidFill>
                  <a:srgbClr val="767676"/>
                </a:solidFill>
                <a:latin typeface="Aptos"/>
                <a:ea typeface="游ゴシック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ja-JP" sz="1200" spc="-1" strike="noStrike">
                <a:solidFill>
                  <a:srgbClr val="767676"/>
                </a:solidFill>
                <a:latin typeface="Aptos"/>
                <a:ea typeface="游ゴシック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45768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200" spc="-1" strike="noStrike">
                <a:solidFill>
                  <a:srgbClr val="767676"/>
                </a:solidFill>
                <a:latin typeface="Aptos"/>
                <a:ea typeface="游ゴシック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7B532E32-DB34-4278-AA84-4395EA516B48}" type="slidenum">
              <a:rPr b="0" lang="ja-JP" sz="1200" spc="-1" strike="noStrike">
                <a:solidFill>
                  <a:srgbClr val="767676"/>
                </a:solidFill>
                <a:latin typeface="Aptos"/>
                <a:ea typeface="游ゴシック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ptos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wmf"/><Relationship Id="rId6" Type="http://schemas.openxmlformats.org/officeDocument/2006/relationships/image" Target="../media/image6.wmf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グラフ 3" descr=""/>
          <p:cNvPicPr/>
          <p:nvPr/>
        </p:nvPicPr>
        <p:blipFill>
          <a:blip r:embed="rId1"/>
          <a:stretch/>
        </p:blipFill>
        <p:spPr>
          <a:xfrm>
            <a:off x="5078520" y="334800"/>
            <a:ext cx="1292040" cy="2279880"/>
          </a:xfrm>
          <a:prstGeom prst="rect">
            <a:avLst/>
          </a:prstGeom>
          <a:ln w="0">
            <a:noFill/>
          </a:ln>
        </p:spPr>
      </p:pic>
      <p:pic>
        <p:nvPicPr>
          <p:cNvPr id="42" name="グラフ 4" descr=""/>
          <p:cNvPicPr/>
          <p:nvPr/>
        </p:nvPicPr>
        <p:blipFill>
          <a:blip r:embed="rId2"/>
          <a:stretch/>
        </p:blipFill>
        <p:spPr>
          <a:xfrm>
            <a:off x="378000" y="324000"/>
            <a:ext cx="4236840" cy="2273040"/>
          </a:xfrm>
          <a:prstGeom prst="rect">
            <a:avLst/>
          </a:prstGeom>
          <a:ln w="0">
            <a:noFill/>
          </a:ln>
        </p:spPr>
      </p:pic>
      <p:pic>
        <p:nvPicPr>
          <p:cNvPr id="43" name="グラフ 5" descr=""/>
          <p:cNvPicPr/>
          <p:nvPr/>
        </p:nvPicPr>
        <p:blipFill>
          <a:blip r:embed="rId3"/>
          <a:stretch/>
        </p:blipFill>
        <p:spPr>
          <a:xfrm>
            <a:off x="378000" y="2828880"/>
            <a:ext cx="8448480" cy="2273400"/>
          </a:xfrm>
          <a:prstGeom prst="rect">
            <a:avLst/>
          </a:prstGeom>
          <a:ln w="0">
            <a:noFill/>
          </a:ln>
        </p:spPr>
      </p:pic>
      <p:pic>
        <p:nvPicPr>
          <p:cNvPr id="44" name="グラフ 6" descr=""/>
          <p:cNvPicPr/>
          <p:nvPr/>
        </p:nvPicPr>
        <p:blipFill>
          <a:blip r:embed="rId4"/>
          <a:stretch/>
        </p:blipFill>
        <p:spPr>
          <a:xfrm>
            <a:off x="6834240" y="334800"/>
            <a:ext cx="1992240" cy="2268720"/>
          </a:xfrm>
          <a:prstGeom prst="rect">
            <a:avLst/>
          </a:prstGeom>
          <a:ln w="0">
            <a:noFill/>
          </a:ln>
        </p:spPr>
      </p:pic>
      <p:grpSp>
        <p:nvGrpSpPr>
          <p:cNvPr id="45" name="グループ化 24"/>
          <p:cNvGrpSpPr/>
          <p:nvPr/>
        </p:nvGrpSpPr>
        <p:grpSpPr>
          <a:xfrm>
            <a:off x="3395520" y="5234040"/>
            <a:ext cx="2551320" cy="311400"/>
            <a:chOff x="3395520" y="5234040"/>
            <a:chExt cx="2551320" cy="311400"/>
          </a:xfrm>
        </p:grpSpPr>
        <p:sp>
          <p:nvSpPr>
            <p:cNvPr id="46" name="テキスト ボックス 18"/>
            <p:cNvSpPr/>
            <p:nvPr/>
          </p:nvSpPr>
          <p:spPr>
            <a:xfrm>
              <a:off x="3474720" y="5234040"/>
              <a:ext cx="8146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游ゴシック"/>
                </a:rPr>
                <a:t>Medaka</a:t>
              </a:r>
              <a:endParaRPr b="0" lang="en-US" sz="1400" spc="-1" strike="noStrike">
                <a:solidFill>
                  <a:srgbClr val="000000"/>
                </a:solidFill>
                <a:latin typeface="Aptos"/>
              </a:endParaRPr>
            </a:p>
          </p:txBody>
        </p:sp>
        <p:pic>
          <p:nvPicPr>
            <p:cNvPr id="47" name="図 20" descr=""/>
            <p:cNvPicPr/>
            <p:nvPr/>
          </p:nvPicPr>
          <p:blipFill>
            <a:blip r:embed="rId5"/>
            <a:stretch/>
          </p:blipFill>
          <p:spPr>
            <a:xfrm>
              <a:off x="3395520" y="5354280"/>
              <a:ext cx="108360" cy="108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8" name="図 22" descr=""/>
            <p:cNvPicPr/>
            <p:nvPr/>
          </p:nvPicPr>
          <p:blipFill>
            <a:blip r:embed="rId6"/>
            <a:stretch/>
          </p:blipFill>
          <p:spPr>
            <a:xfrm>
              <a:off x="4642920" y="5354280"/>
              <a:ext cx="121680" cy="108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9" name="テキスト ボックス 23"/>
            <p:cNvSpPr/>
            <p:nvPr/>
          </p:nvSpPr>
          <p:spPr>
            <a:xfrm>
              <a:off x="4751280" y="5238360"/>
              <a:ext cx="11955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游ゴシック"/>
                </a:rPr>
                <a:t>Pacific saury</a:t>
              </a:r>
              <a:endParaRPr b="0" lang="en-US" sz="1400" spc="-1" strike="noStrike">
                <a:solidFill>
                  <a:srgbClr val="000000"/>
                </a:solidFill>
                <a:latin typeface="Aptos"/>
              </a:endParaRPr>
            </a:p>
          </p:txBody>
        </p:sp>
      </p:grpSp>
      <p:sp>
        <p:nvSpPr>
          <p:cNvPr id="50" name="テキスト ボックス 25"/>
          <p:cNvSpPr/>
          <p:nvPr/>
        </p:nvSpPr>
        <p:spPr>
          <a:xfrm>
            <a:off x="388800" y="5856120"/>
            <a:ext cx="845028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Supplementary figure. Comparison of the subfamilies of repetitive elements between the medaka genome and the Pacific saury genome.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游ゴシック"/>
              </a:rPr>
              <a:t>The subfamilies of LINEs, DNA transposons, Rolling-circles, and unclassified repeats were examined.</a:t>
            </a:r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  <p:sp>
        <p:nvSpPr>
          <p:cNvPr id="51" name="正方形/長方形 26"/>
          <p:cNvSpPr/>
          <p:nvPr/>
        </p:nvSpPr>
        <p:spPr>
          <a:xfrm>
            <a:off x="3195720" y="5234040"/>
            <a:ext cx="2873160" cy="3636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ptos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4-01-19T08:20:31Z</dcterms:created>
  <dc:creator>中村　洋路</dc:creator>
  <dc:description/>
  <dc:language>en-US</dc:language>
  <cp:lastModifiedBy>中村　洋路</cp:lastModifiedBy>
  <dcterms:modified xsi:type="dcterms:W3CDTF">2024-01-29T03:16:32Z</dcterms:modified>
  <cp:revision>8</cp:revision>
  <dc:subject/>
  <dc:title>PowerPoint プレゼンテーション</dc:title>
</cp:coreProperties>
</file>